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981" r:id="rId2"/>
  </p:sldIdLst>
  <p:sldSz cx="6858000" cy="9906000" type="A4"/>
  <p:notesSz cx="6858000" cy="9144000"/>
  <p:defaultTextStyle>
    <a:defPPr>
      <a:defRPr lang="en-US"/>
    </a:defPPr>
    <a:lvl1pPr marL="0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1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00"/>
    <a:srgbClr val="FCEEF7"/>
    <a:srgbClr val="FBE9FB"/>
    <a:srgbClr val="F8DC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3784" autoAdjust="0"/>
  </p:normalViewPr>
  <p:slideViewPr>
    <p:cSldViewPr snapToGrid="0">
      <p:cViewPr>
        <p:scale>
          <a:sx n="125" d="100"/>
          <a:sy n="125" d="100"/>
        </p:scale>
        <p:origin x="1170" y="90"/>
      </p:cViewPr>
      <p:guideLst>
        <p:guide orient="horz" pos="3121"/>
        <p:guide pos="2161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92F547-D850-4018-AA1D-F8DCC99CCBEA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6AFB34-6CFC-498A-BE1B-552DE47A8E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879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1621194"/>
            <a:ext cx="5829300" cy="344875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1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2940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503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6"/>
            <a:ext cx="1478755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6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39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422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7"/>
            <a:ext cx="5915025" cy="412061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5"/>
            <a:ext cx="5915025" cy="216693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263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9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5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26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8"/>
            <a:ext cx="5915025" cy="191470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0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0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6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6026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903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8034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665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8"/>
            <a:ext cx="5915025" cy="19147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9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96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3EB8A4A-C66E-5F6F-2247-100D48989E7F}"/>
              </a:ext>
            </a:extLst>
          </p:cNvPr>
          <p:cNvSpPr txBox="1"/>
          <p:nvPr/>
        </p:nvSpPr>
        <p:spPr>
          <a:xfrm>
            <a:off x="18338" y="441733"/>
            <a:ext cx="68507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urgical specimen</a:t>
            </a:r>
            <a:endParaRPr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0B81611-446C-CB32-3232-443ACE694544}"/>
              </a:ext>
            </a:extLst>
          </p:cNvPr>
          <p:cNvSpPr txBox="1"/>
          <p:nvPr/>
        </p:nvSpPr>
        <p:spPr>
          <a:xfrm>
            <a:off x="2" y="20965"/>
            <a:ext cx="68409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Relation between expression of CD3,CD8,Foxp3 and CCR8 lymphocytes and </a:t>
            </a:r>
            <a:r>
              <a:rPr lang="en-US" altLang="ja-JP" sz="1200" b="1" u="sng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nivolumab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5" name="図 34">
            <a:extLst>
              <a:ext uri="{FF2B5EF4-FFF2-40B4-BE49-F238E27FC236}">
                <a16:creationId xmlns:a16="http://schemas.microsoft.com/office/drawing/2014/main" id="{3E8195A7-E45D-37A2-2B6A-0EDE722981B6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0720" y="834839"/>
            <a:ext cx="3037305" cy="1872000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4D346942-84D5-FD2D-7EDF-91AF6190F5EB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67548" y="850804"/>
            <a:ext cx="3037305" cy="1872000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7559D5B4-C8D4-43A2-713F-E1750A16B48C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0794" y="2850218"/>
            <a:ext cx="2977157" cy="1872000"/>
          </a:xfrm>
          <a:prstGeom prst="rect">
            <a:avLst/>
          </a:prstGeom>
        </p:spPr>
      </p:pic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51444AB-CD71-F33E-67D6-8514DEB32E23}"/>
              </a:ext>
            </a:extLst>
          </p:cNvPr>
          <p:cNvSpPr txBox="1"/>
          <p:nvPr/>
        </p:nvSpPr>
        <p:spPr>
          <a:xfrm>
            <a:off x="855121" y="2466612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5A2B7CA-6A09-598C-C3EF-A77D5DA0B64E}"/>
              </a:ext>
            </a:extLst>
          </p:cNvPr>
          <p:cNvSpPr txBox="1"/>
          <p:nvPr/>
        </p:nvSpPr>
        <p:spPr>
          <a:xfrm rot="16200000">
            <a:off x="-1021725" y="1462122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C4807576-96FC-B6DC-0DE6-E69321F740C8}"/>
              </a:ext>
            </a:extLst>
          </p:cNvPr>
          <p:cNvSpPr txBox="1"/>
          <p:nvPr/>
        </p:nvSpPr>
        <p:spPr>
          <a:xfrm>
            <a:off x="670686" y="1997219"/>
            <a:ext cx="107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40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0BBB463-14E6-4F16-70C3-FEACEC740280}"/>
              </a:ext>
            </a:extLst>
          </p:cNvPr>
          <p:cNvSpPr txBox="1"/>
          <p:nvPr/>
        </p:nvSpPr>
        <p:spPr>
          <a:xfrm>
            <a:off x="4259270" y="2471171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103FE07-1D71-A44D-56E5-65378D8FADA8}"/>
              </a:ext>
            </a:extLst>
          </p:cNvPr>
          <p:cNvSpPr txBox="1"/>
          <p:nvPr/>
        </p:nvSpPr>
        <p:spPr>
          <a:xfrm rot="16200000">
            <a:off x="2415334" y="1466681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870DBDC-5CCD-33FB-0A5C-F405831F4CEA}"/>
              </a:ext>
            </a:extLst>
          </p:cNvPr>
          <p:cNvSpPr txBox="1"/>
          <p:nvPr/>
        </p:nvSpPr>
        <p:spPr>
          <a:xfrm>
            <a:off x="4074835" y="2001778"/>
            <a:ext cx="107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181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42FC9BA-6C78-9398-528C-E4C83916ACE6}"/>
              </a:ext>
            </a:extLst>
          </p:cNvPr>
          <p:cNvSpPr txBox="1"/>
          <p:nvPr/>
        </p:nvSpPr>
        <p:spPr>
          <a:xfrm>
            <a:off x="789302" y="4437548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03C29DB4-3FA2-21EE-1017-64D708AEF5D0}"/>
              </a:ext>
            </a:extLst>
          </p:cNvPr>
          <p:cNvSpPr txBox="1"/>
          <p:nvPr/>
        </p:nvSpPr>
        <p:spPr>
          <a:xfrm rot="16200000">
            <a:off x="-1021725" y="3433058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866D90E9-4F4B-B8AD-B611-F4BBBB9D402A}"/>
              </a:ext>
            </a:extLst>
          </p:cNvPr>
          <p:cNvSpPr txBox="1"/>
          <p:nvPr/>
        </p:nvSpPr>
        <p:spPr>
          <a:xfrm>
            <a:off x="604867" y="3993555"/>
            <a:ext cx="107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11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D4F9C78-53EF-11F2-05E1-F4E23F13DDF7}"/>
              </a:ext>
            </a:extLst>
          </p:cNvPr>
          <p:cNvSpPr txBox="1"/>
          <p:nvPr/>
        </p:nvSpPr>
        <p:spPr>
          <a:xfrm>
            <a:off x="1837817" y="815276"/>
            <a:ext cx="17407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 high (n=65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 low (n=64)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42CDB998-CFAD-BB87-1DBA-CBA6A8008928}"/>
              </a:ext>
            </a:extLst>
          </p:cNvPr>
          <p:cNvSpPr txBox="1"/>
          <p:nvPr/>
        </p:nvSpPr>
        <p:spPr>
          <a:xfrm>
            <a:off x="5241966" y="819835"/>
            <a:ext cx="17407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 high (n=65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 low (n=64)</a:t>
            </a: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A6FE815-3060-BB21-C500-6128FA1B5579}"/>
              </a:ext>
            </a:extLst>
          </p:cNvPr>
          <p:cNvSpPr txBox="1"/>
          <p:nvPr/>
        </p:nvSpPr>
        <p:spPr>
          <a:xfrm>
            <a:off x="1771998" y="2786212"/>
            <a:ext cx="17407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 high (n=65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 low (n=64)</a:t>
            </a:r>
          </a:p>
        </p:txBody>
      </p:sp>
      <p:pic>
        <p:nvPicPr>
          <p:cNvPr id="53" name="図 52">
            <a:extLst>
              <a:ext uri="{FF2B5EF4-FFF2-40B4-BE49-F238E27FC236}">
                <a16:creationId xmlns:a16="http://schemas.microsoft.com/office/drawing/2014/main" id="{E2B7B80D-E998-BF86-99D1-BCFCED709A37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56274" y="2803976"/>
            <a:ext cx="3059853" cy="1872000"/>
          </a:xfrm>
          <a:prstGeom prst="rect">
            <a:avLst/>
          </a:prstGeom>
        </p:spPr>
      </p:pic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FA13E84-1FDA-2CDF-6842-DAF75D468B0F}"/>
              </a:ext>
            </a:extLst>
          </p:cNvPr>
          <p:cNvSpPr txBox="1"/>
          <p:nvPr/>
        </p:nvSpPr>
        <p:spPr>
          <a:xfrm>
            <a:off x="4247386" y="4438020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E29FBBC9-39AE-0029-B2C6-894712337475}"/>
              </a:ext>
            </a:extLst>
          </p:cNvPr>
          <p:cNvSpPr txBox="1"/>
          <p:nvPr/>
        </p:nvSpPr>
        <p:spPr>
          <a:xfrm>
            <a:off x="4062951" y="3968627"/>
            <a:ext cx="107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090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AA5312D3-4515-ECB2-4270-9BC994A4556D}"/>
              </a:ext>
            </a:extLst>
          </p:cNvPr>
          <p:cNvSpPr txBox="1"/>
          <p:nvPr/>
        </p:nvSpPr>
        <p:spPr>
          <a:xfrm>
            <a:off x="4947190" y="2808399"/>
            <a:ext cx="20974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/Foxp3 high (n=65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/Foxp3 low (n=64)</a:t>
            </a: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F5B27181-7AEA-6207-2B1B-0EBD86BF11E4}"/>
              </a:ext>
            </a:extLst>
          </p:cNvPr>
          <p:cNvSpPr txBox="1"/>
          <p:nvPr/>
        </p:nvSpPr>
        <p:spPr>
          <a:xfrm rot="16200000">
            <a:off x="2403450" y="3433530"/>
            <a:ext cx="2584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</p:spTree>
    <p:extLst>
      <p:ext uri="{BB962C8B-B14F-4D97-AF65-F5344CB8AC3E}">
        <p14:creationId xmlns:p14="http://schemas.microsoft.com/office/powerpoint/2010/main" val="4163273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1012</TotalTime>
  <Words>134</Words>
  <Application>Microsoft Office PowerPoint</Application>
  <PresentationFormat>A4 210 x 297 mm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omi1001</dc:creator>
  <cp:lastModifiedBy>慈人 中井</cp:lastModifiedBy>
  <cp:revision>3160</cp:revision>
  <dcterms:created xsi:type="dcterms:W3CDTF">2017-04-11T12:43:51Z</dcterms:created>
  <dcterms:modified xsi:type="dcterms:W3CDTF">2025-02-05T06:58:56Z</dcterms:modified>
</cp:coreProperties>
</file>